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1" r:id="rId3"/>
    <p:sldId id="269" r:id="rId4"/>
    <p:sldId id="267" r:id="rId5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36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FBF59F0-3390-4879-B3B2-E50DF189FC0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9CDE9A7D-8ECF-4586-AB85-6EBDD65B148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74C5CFDC-B444-4739-8258-F213F813DF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307587-8878-4BDD-9538-4109AC7B5D37}" type="datetimeFigureOut">
              <a:rPr lang="pt-BR" smtClean="0"/>
              <a:t>14/10/20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2A926FA7-F041-4483-A6E0-9703D39430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FC12B743-2609-4D8E-A9BA-5DAA94360A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BF2C3-74E2-47BF-8F9C-814AC2CADFB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095904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7FB0F81-2409-4488-B791-A680DBDEB7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90A28B1C-5A2A-4CE0-9A72-BD3825319B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4E9B4368-0B7F-4A5F-BD1E-962520D43B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307587-8878-4BDD-9538-4109AC7B5D37}" type="datetimeFigureOut">
              <a:rPr lang="pt-BR" smtClean="0"/>
              <a:t>14/10/20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CF18DCBA-E0F8-47A1-8211-0D4161231D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665CC990-B850-45E5-8166-12119AE109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BF2C3-74E2-47BF-8F9C-814AC2CADFB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165548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B3CE88AE-ADD3-4F1C-AA38-BD6BC30A944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A667F006-7DCA-49A5-8D90-391A38C0EC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23B3B269-7DE8-447C-A1B8-487E7D56B7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307587-8878-4BDD-9538-4109AC7B5D37}" type="datetimeFigureOut">
              <a:rPr lang="pt-BR" smtClean="0"/>
              <a:t>14/10/20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241D1E30-619E-4DAB-BB5F-D0CFBAECD5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A06FD56C-E726-4471-AB2B-29DA0AE049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BF2C3-74E2-47BF-8F9C-814AC2CADFB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880275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37DBE58-04B6-4A41-8D58-F700D5AEEE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2C728C65-B5AF-4EB4-B52D-04201EF6FB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3513CB6-2B6C-4C70-84B2-BF4B4A28AE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307587-8878-4BDD-9538-4109AC7B5D37}" type="datetimeFigureOut">
              <a:rPr lang="pt-BR" smtClean="0"/>
              <a:t>14/10/20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535123F6-F99B-4BC0-B438-18A5179B71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3EDB8AC-508F-4202-B87A-BD04AD5152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BF2C3-74E2-47BF-8F9C-814AC2CADFB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16474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D467591-0EAF-469A-8A9F-3B3A9231DB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7EB91046-699F-4CED-844C-39F7C344DB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9B721C17-B743-4E00-BFB5-5D45B4E4BF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307587-8878-4BDD-9538-4109AC7B5D37}" type="datetimeFigureOut">
              <a:rPr lang="pt-BR" smtClean="0"/>
              <a:t>14/10/20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E29ABA84-2215-442B-8BB6-E16E971D17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8B426426-DBB8-4C1F-B34E-D6F3C7DAFD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BF2C3-74E2-47BF-8F9C-814AC2CADFB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28110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D549204-12A6-4F80-A8CF-D08C3B24F2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ECED4280-38C4-4437-B174-1AFC0E3194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B69C9849-BF80-4BF7-9282-3EE631CE00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688E9A04-C1D1-4CB0-8445-3E8C38FBCA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307587-8878-4BDD-9538-4109AC7B5D37}" type="datetimeFigureOut">
              <a:rPr lang="pt-BR" smtClean="0"/>
              <a:t>14/10/2020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800CB0D6-D797-404A-A778-3DD9B76106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6761B143-0CFE-4A30-9F6E-FBB81A0075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BF2C3-74E2-47BF-8F9C-814AC2CADFB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08618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60B254F-CE94-4D1C-92A5-BDD0F18492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59CAC7CE-DBD0-4195-A5BF-E20ACA749B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108E959C-157E-4CFC-B49C-BD81F48087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B3F06142-AF19-4AC1-B8EB-F9A230D9BF7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C3E9095A-89A9-4C6F-A815-DC19A848BB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35EEE54D-343E-4690-B61A-E5EAD03E8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307587-8878-4BDD-9538-4109AC7B5D37}" type="datetimeFigureOut">
              <a:rPr lang="pt-BR" smtClean="0"/>
              <a:t>14/10/2020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923DDB5D-551E-48F0-8CB4-EC9E9BF2B4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4D8F19D2-59AA-421F-9FE5-088B5E0BC1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BF2C3-74E2-47BF-8F9C-814AC2CADFB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26239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B8E8594-13B8-416B-816A-EB04CC7118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08F981B7-9BAB-40E9-A560-A49BEFB65C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307587-8878-4BDD-9538-4109AC7B5D37}" type="datetimeFigureOut">
              <a:rPr lang="pt-BR" smtClean="0"/>
              <a:t>14/10/2020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1D97F357-957E-43C7-88EE-3B2A870E65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07D4A72D-7BF0-41FA-B13A-42EE2A1C9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BF2C3-74E2-47BF-8F9C-814AC2CADFB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369092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C6B10C99-7B3D-4554-8496-23D3EEB0C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307587-8878-4BDD-9538-4109AC7B5D37}" type="datetimeFigureOut">
              <a:rPr lang="pt-BR" smtClean="0"/>
              <a:t>14/10/2020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599F50D2-B908-4F5F-A223-9E282EDBF4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1406027A-1FAA-4539-9EC3-BCB45ABD5A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BF2C3-74E2-47BF-8F9C-814AC2CADFB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920773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5A3D59D-871C-4E4A-9C07-AD8CC9D95D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87587CD1-98A4-482A-BDAA-23BC9505A5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5F1F9D54-8445-40E1-9D1A-0F7A2E84BA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1083BE4D-49FA-4F2E-BB81-727BE21E94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307587-8878-4BDD-9538-4109AC7B5D37}" type="datetimeFigureOut">
              <a:rPr lang="pt-BR" smtClean="0"/>
              <a:t>14/10/2020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DB1F47E2-BDF6-4EA7-B805-CE7B3CCAD7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672834F3-FD1C-4B29-8AC5-910F295A93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BF2C3-74E2-47BF-8F9C-814AC2CADFB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046024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EBAE835-7E19-4989-9AB1-C3C4B7A8E3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B74016D1-6923-47C7-B71F-6A8974038D2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0E0BDD4C-FB3E-4810-A7E3-CF3D56F1BC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85870B12-E547-4CFB-8DE6-77AF11C97E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307587-8878-4BDD-9538-4109AC7B5D37}" type="datetimeFigureOut">
              <a:rPr lang="pt-BR" smtClean="0"/>
              <a:t>14/10/2020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37B70AE3-78A1-4B9B-9049-752953E6F3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56B8D88C-4120-414F-830B-5B94D0EEB5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BF2C3-74E2-47BF-8F9C-814AC2CADFB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281691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28D465C7-E3A8-4A35-B4C5-92EA3FD076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5491E41D-7780-4BB7-8D95-48793FA4C5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99C4B77-CB23-4473-835D-83FB7ECE546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307587-8878-4BDD-9538-4109AC7B5D37}" type="datetimeFigureOut">
              <a:rPr lang="pt-BR" smtClean="0"/>
              <a:t>14/10/20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4476B9E5-577E-4125-A2D5-CCEA22BA9A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7C224A0C-0779-4427-BD71-7A36F7046DD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DBF2C3-74E2-47BF-8F9C-814AC2CADFB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49059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gcolleoni@unifesp.br" TargetMode="External"/><Relationship Id="rId2" Type="http://schemas.openxmlformats.org/officeDocument/2006/relationships/hyperlink" Target="mailto:ismael.dale2@gmail.com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338316E-6889-4088-ABC5-40D64ADCEE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349071" y="160255"/>
            <a:ext cx="9144000" cy="2387600"/>
          </a:xfrm>
        </p:spPr>
        <p:txBody>
          <a:bodyPr>
            <a:normAutofit/>
          </a:bodyPr>
          <a:lstStyle/>
          <a:p>
            <a:r>
              <a:rPr lang="en-US" sz="2000" b="1" dirty="0"/>
              <a:t>Biochemical Phenotyping </a:t>
            </a:r>
            <a:r>
              <a:rPr lang="pt-BR" sz="2000" b="1" dirty="0" err="1"/>
              <a:t>of</a:t>
            </a:r>
            <a:r>
              <a:rPr lang="pt-BR" sz="2000" b="1" dirty="0"/>
              <a:t> </a:t>
            </a:r>
            <a:r>
              <a:rPr lang="pt-BR" sz="2000" b="1" dirty="0" err="1"/>
              <a:t>Multiple</a:t>
            </a:r>
            <a:r>
              <a:rPr lang="pt-BR" sz="2000" b="1" dirty="0"/>
              <a:t> </a:t>
            </a:r>
            <a:r>
              <a:rPr lang="pt-BR" sz="2000" b="1" dirty="0" err="1"/>
              <a:t>Myeloma</a:t>
            </a:r>
            <a:r>
              <a:rPr lang="pt-BR" sz="2000" b="1" dirty="0"/>
              <a:t> </a:t>
            </a:r>
            <a:r>
              <a:rPr lang="pt-BR" sz="2000" b="1" dirty="0" err="1"/>
              <a:t>Patients</a:t>
            </a:r>
            <a:r>
              <a:rPr lang="pt-BR" sz="2000" b="1" dirty="0"/>
              <a:t> </a:t>
            </a:r>
            <a:r>
              <a:rPr lang="pt-BR" sz="2000" b="1" dirty="0" err="1"/>
              <a:t>at</a:t>
            </a:r>
            <a:r>
              <a:rPr lang="pt-BR" sz="2000" b="1" dirty="0"/>
              <a:t> </a:t>
            </a:r>
            <a:r>
              <a:rPr lang="pt-BR" sz="2000" b="1" dirty="0" err="1"/>
              <a:t>Diagnosis</a:t>
            </a:r>
            <a:r>
              <a:rPr lang="pt-BR" sz="2000" b="1" dirty="0"/>
              <a:t> </a:t>
            </a:r>
            <a:r>
              <a:rPr lang="en-US" sz="2000" b="1" dirty="0"/>
              <a:t>Reveals </a:t>
            </a:r>
            <a:r>
              <a:rPr lang="pt-BR" sz="2000" b="1" dirty="0"/>
              <a:t>a </a:t>
            </a:r>
            <a:r>
              <a:rPr lang="pt-BR" sz="2000" b="1" dirty="0" err="1"/>
              <a:t>Disorder</a:t>
            </a:r>
            <a:r>
              <a:rPr lang="pt-BR" sz="2000" b="1" dirty="0"/>
              <a:t> </a:t>
            </a:r>
            <a:r>
              <a:rPr lang="pt-BR" sz="2000" b="1" dirty="0" err="1"/>
              <a:t>of</a:t>
            </a:r>
            <a:r>
              <a:rPr lang="pt-BR" sz="2000" b="1" dirty="0"/>
              <a:t> </a:t>
            </a:r>
            <a:r>
              <a:rPr lang="pt-BR" sz="2000" b="1" dirty="0" err="1"/>
              <a:t>Mitochondrial</a:t>
            </a:r>
            <a:r>
              <a:rPr lang="pt-BR" sz="2000" b="1" dirty="0"/>
              <a:t> Complexes I </a:t>
            </a:r>
            <a:r>
              <a:rPr lang="pt-BR" sz="2000" b="1" dirty="0" err="1"/>
              <a:t>and</a:t>
            </a:r>
            <a:r>
              <a:rPr lang="pt-BR" sz="2000" b="1" dirty="0"/>
              <a:t> II </a:t>
            </a:r>
            <a:r>
              <a:rPr lang="pt-BR" sz="2000" b="1" dirty="0" err="1"/>
              <a:t>and</a:t>
            </a:r>
            <a:r>
              <a:rPr lang="pt-BR" sz="2000" b="1" dirty="0"/>
              <a:t> a </a:t>
            </a:r>
            <a:r>
              <a:rPr lang="en-US" sz="2000" b="1" dirty="0" err="1"/>
              <a:t>Hartnup</a:t>
            </a:r>
            <a:r>
              <a:rPr lang="en-US" sz="2000" b="1" dirty="0"/>
              <a:t>-Like Disturbance as Underlying Conditions, also Influencing </a:t>
            </a:r>
            <a:r>
              <a:rPr lang="pt-BR" sz="2000" b="1" dirty="0" err="1"/>
              <a:t>Different</a:t>
            </a:r>
            <a:r>
              <a:rPr lang="pt-BR" sz="2000" b="1" dirty="0"/>
              <a:t> </a:t>
            </a:r>
            <a:r>
              <a:rPr lang="pt-BR" sz="2000" b="1" dirty="0" err="1"/>
              <a:t>Stages</a:t>
            </a:r>
            <a:r>
              <a:rPr lang="pt-BR" sz="2000" b="1" dirty="0"/>
              <a:t> </a:t>
            </a:r>
            <a:r>
              <a:rPr lang="pt-BR" sz="2000" b="1" dirty="0" err="1"/>
              <a:t>of</a:t>
            </a:r>
            <a:r>
              <a:rPr lang="pt-BR" sz="2000" b="1" dirty="0"/>
              <a:t> </a:t>
            </a:r>
            <a:r>
              <a:rPr lang="pt-BR" sz="2000" b="1" dirty="0" err="1"/>
              <a:t>the</a:t>
            </a:r>
            <a:r>
              <a:rPr lang="pt-BR" sz="2000" b="1" dirty="0"/>
              <a:t> </a:t>
            </a:r>
            <a:r>
              <a:rPr lang="pt-BR" sz="2000" b="1" dirty="0" err="1"/>
              <a:t>Disease</a:t>
            </a:r>
            <a:r>
              <a:rPr lang="pt-BR" sz="2000" b="1" dirty="0"/>
              <a:t> </a:t>
            </a:r>
            <a:br>
              <a:rPr lang="pt-BR" dirty="0"/>
            </a:br>
            <a:endParaRPr lang="pt-BR" dirty="0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74974893-6A0F-446D-9E97-D378E364FAB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2671638"/>
            <a:ext cx="9144000" cy="3864334"/>
          </a:xfrm>
        </p:spPr>
        <p:txBody>
          <a:bodyPr>
            <a:normAutofit fontScale="55000" lnSpcReduction="20000"/>
          </a:bodyPr>
          <a:lstStyle/>
          <a:p>
            <a:pPr algn="l"/>
            <a:r>
              <a:rPr lang="pt-BR" dirty="0"/>
              <a:t>Ismael Dale Cotrim Guerreiro da Silva</a:t>
            </a:r>
            <a:r>
              <a:rPr lang="pt-BR" baseline="30000" dirty="0"/>
              <a:t>1*</a:t>
            </a:r>
            <a:endParaRPr lang="pt-BR" dirty="0"/>
          </a:p>
          <a:p>
            <a:pPr algn="l"/>
            <a:r>
              <a:rPr lang="pt-BR" dirty="0"/>
              <a:t>Erica Valadares de Castro Levatti</a:t>
            </a:r>
            <a:r>
              <a:rPr lang="pt-BR" baseline="30000" dirty="0"/>
              <a:t>2*</a:t>
            </a:r>
            <a:endParaRPr lang="pt-BR" dirty="0"/>
          </a:p>
          <a:p>
            <a:pPr algn="l"/>
            <a:r>
              <a:rPr lang="pt-BR" dirty="0"/>
              <a:t>Amanda Paula Pedroso</a:t>
            </a:r>
            <a:r>
              <a:rPr lang="pt-BR" baseline="30000" dirty="0"/>
              <a:t>3</a:t>
            </a:r>
            <a:endParaRPr lang="pt-BR" dirty="0"/>
          </a:p>
          <a:p>
            <a:pPr algn="l"/>
            <a:r>
              <a:rPr lang="pt-BR" dirty="0"/>
              <a:t>Dirce Maria Lobo Marchioni</a:t>
            </a:r>
            <a:r>
              <a:rPr lang="pt-BR" baseline="30000" dirty="0"/>
              <a:t>4</a:t>
            </a:r>
            <a:endParaRPr lang="pt-BR" dirty="0"/>
          </a:p>
          <a:p>
            <a:pPr algn="l"/>
            <a:r>
              <a:rPr lang="pt-BR" dirty="0" err="1"/>
              <a:t>Antonio</a:t>
            </a:r>
            <a:r>
              <a:rPr lang="pt-BR" dirty="0"/>
              <a:t> Augusto Ferreira Carioca</a:t>
            </a:r>
            <a:r>
              <a:rPr lang="pt-BR" baseline="30000" dirty="0"/>
              <a:t>4</a:t>
            </a:r>
            <a:endParaRPr lang="pt-BR" dirty="0"/>
          </a:p>
          <a:p>
            <a:pPr algn="l"/>
            <a:r>
              <a:rPr lang="pt-BR" dirty="0"/>
              <a:t>Gisele Wally Braga Colleoni</a:t>
            </a:r>
            <a:r>
              <a:rPr lang="pt-BR" baseline="30000" dirty="0"/>
              <a:t>2</a:t>
            </a:r>
            <a:endParaRPr lang="pt-BR" dirty="0"/>
          </a:p>
          <a:p>
            <a:pPr algn="l"/>
            <a:r>
              <a:rPr lang="en-US" i="1" baseline="30000" dirty="0"/>
              <a:t>1</a:t>
            </a:r>
            <a:r>
              <a:rPr lang="en-US" i="1" dirty="0"/>
              <a:t>Departament of Gynecology, </a:t>
            </a:r>
            <a:r>
              <a:rPr lang="en-US" i="1" dirty="0" err="1"/>
              <a:t>Paulista</a:t>
            </a:r>
            <a:r>
              <a:rPr lang="en-US" i="1" dirty="0"/>
              <a:t> School of Medicine, Federal University of São Paulo, São Paulo, Brazil</a:t>
            </a:r>
            <a:endParaRPr lang="pt-BR" dirty="0"/>
          </a:p>
          <a:p>
            <a:pPr algn="l"/>
            <a:r>
              <a:rPr lang="en-US" i="1" baseline="30000" dirty="0"/>
              <a:t>2</a:t>
            </a:r>
            <a:r>
              <a:rPr lang="en-US" i="1" dirty="0"/>
              <a:t>Department of Clinical and Experimental Oncology, </a:t>
            </a:r>
            <a:r>
              <a:rPr lang="en-US" i="1" dirty="0" err="1"/>
              <a:t>Paulista</a:t>
            </a:r>
            <a:r>
              <a:rPr lang="en-US" i="1" dirty="0"/>
              <a:t> School of Medicine, Federal University of São Paulo, São Paulo, Brazil</a:t>
            </a:r>
            <a:endParaRPr lang="pt-BR" dirty="0"/>
          </a:p>
          <a:p>
            <a:pPr algn="l"/>
            <a:r>
              <a:rPr lang="en-US" i="1" baseline="30000" dirty="0"/>
              <a:t>3</a:t>
            </a:r>
            <a:r>
              <a:rPr lang="en-US" i="1" dirty="0"/>
              <a:t>Departament of Physiology, </a:t>
            </a:r>
            <a:r>
              <a:rPr lang="en-US" i="1" dirty="0" err="1"/>
              <a:t>Paulista</a:t>
            </a:r>
            <a:r>
              <a:rPr lang="en-US" i="1" dirty="0"/>
              <a:t> School of Medicine, Federal University of São Paulo, São Paulo, Brazil</a:t>
            </a:r>
            <a:endParaRPr lang="pt-BR" dirty="0"/>
          </a:p>
          <a:p>
            <a:pPr algn="l"/>
            <a:r>
              <a:rPr lang="en-US" i="1" baseline="30000" dirty="0"/>
              <a:t>4</a:t>
            </a:r>
            <a:r>
              <a:rPr lang="en-US" i="1" dirty="0"/>
              <a:t>Nutrition Department, School of Public Health, University of São Paulo School of Medicine (FMUSP), São Paulo, Brazil</a:t>
            </a:r>
            <a:endParaRPr lang="pt-BR" dirty="0"/>
          </a:p>
          <a:p>
            <a:pPr algn="l"/>
            <a:r>
              <a:rPr lang="en-US" i="1" dirty="0"/>
              <a:t>*Both are first authors.</a:t>
            </a:r>
            <a:endParaRPr lang="pt-BR" dirty="0"/>
          </a:p>
          <a:p>
            <a:pPr algn="l"/>
            <a:r>
              <a:rPr lang="en-US" b="1" dirty="0"/>
              <a:t>Correspondence to: </a:t>
            </a:r>
            <a:endParaRPr lang="pt-BR" i="1" dirty="0"/>
          </a:p>
          <a:p>
            <a:pPr algn="l"/>
            <a:r>
              <a:rPr lang="pt-BR" dirty="0"/>
              <a:t>Ismael Dale C. G. Silva, </a:t>
            </a:r>
            <a:r>
              <a:rPr lang="pt-BR" i="1" u="sng" dirty="0">
                <a:hlinkClick r:id="rId2"/>
              </a:rPr>
              <a:t>ismael.dale2@gmail.com</a:t>
            </a:r>
            <a:r>
              <a:rPr lang="pt-BR" i="1" u="sng" dirty="0"/>
              <a:t>, ismael.silva@grupofleury.com.br</a:t>
            </a:r>
            <a:endParaRPr lang="pt-BR" i="1" dirty="0"/>
          </a:p>
          <a:p>
            <a:pPr algn="l"/>
            <a:r>
              <a:rPr lang="en-US" dirty="0"/>
              <a:t>Gisele Colleoni, </a:t>
            </a:r>
            <a:r>
              <a:rPr lang="en-US" u="sng" dirty="0">
                <a:hlinkClick r:id="rId3"/>
              </a:rPr>
              <a:t>gcolleoni@unifesp.br</a:t>
            </a:r>
            <a:endParaRPr lang="pt-BR" dirty="0"/>
          </a:p>
          <a:p>
            <a:pPr algn="l"/>
            <a:endParaRPr lang="pt-BR" dirty="0"/>
          </a:p>
        </p:txBody>
      </p:sp>
      <p:sp>
        <p:nvSpPr>
          <p:cNvPr id="4" name="Título 3">
            <a:extLst>
              <a:ext uri="{FF2B5EF4-FFF2-40B4-BE49-F238E27FC236}">
                <a16:creationId xmlns:a16="http://schemas.microsoft.com/office/drawing/2014/main" id="{5FAAE514-6C41-460F-A3F8-516DE0FD4846}"/>
              </a:ext>
            </a:extLst>
          </p:cNvPr>
          <p:cNvSpPr txBox="1">
            <a:spLocks/>
          </p:cNvSpPr>
          <p:nvPr/>
        </p:nvSpPr>
        <p:spPr>
          <a:xfrm>
            <a:off x="192088" y="-139700"/>
            <a:ext cx="2284412" cy="890588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pt-BR" sz="1600" b="1" dirty="0" err="1"/>
              <a:t>Supplemental</a:t>
            </a:r>
            <a:r>
              <a:rPr lang="pt-BR" sz="1600" b="1" dirty="0"/>
              <a:t> material</a:t>
            </a:r>
          </a:p>
        </p:txBody>
      </p:sp>
    </p:spTree>
    <p:extLst>
      <p:ext uri="{BB962C8B-B14F-4D97-AF65-F5344CB8AC3E}">
        <p14:creationId xmlns:p14="http://schemas.microsoft.com/office/powerpoint/2010/main" val="37127131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ítulo 3">
            <a:extLst>
              <a:ext uri="{FF2B5EF4-FFF2-40B4-BE49-F238E27FC236}">
                <a16:creationId xmlns:a16="http://schemas.microsoft.com/office/drawing/2014/main" id="{EAEBCACA-FCA6-4E53-B604-78E5463EB7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92088" y="-139700"/>
            <a:ext cx="2284412" cy="890588"/>
          </a:xfrm>
        </p:spPr>
        <p:txBody>
          <a:bodyPr>
            <a:normAutofit/>
          </a:bodyPr>
          <a:lstStyle/>
          <a:p>
            <a:r>
              <a:rPr lang="pt-BR" sz="1600" b="1" dirty="0" err="1"/>
              <a:t>Supplemental</a:t>
            </a:r>
            <a:r>
              <a:rPr lang="pt-BR" sz="1600" b="1" dirty="0"/>
              <a:t> material 1</a:t>
            </a:r>
          </a:p>
        </p:txBody>
      </p:sp>
      <p:graphicFrame>
        <p:nvGraphicFramePr>
          <p:cNvPr id="13" name="Espaço Reservado para Conteúdo 12">
            <a:extLst>
              <a:ext uri="{FF2B5EF4-FFF2-40B4-BE49-F238E27FC236}">
                <a16:creationId xmlns:a16="http://schemas.microsoft.com/office/drawing/2014/main" id="{B36D27FD-0C1A-44E8-AD5E-22FF2EFFF8F9}"/>
              </a:ext>
            </a:extLst>
          </p:cNvPr>
          <p:cNvGraphicFramePr>
            <a:graphicFrameLocks noGrp="1"/>
          </p:cNvGraphicFramePr>
          <p:nvPr>
            <p:ph sz="half" idx="2"/>
          </p:nvPr>
        </p:nvGraphicFramePr>
        <p:xfrm>
          <a:off x="2476500" y="292100"/>
          <a:ext cx="2971800" cy="6472813"/>
        </p:xfrm>
        <a:graphic>
          <a:graphicData uri="http://schemas.openxmlformats.org/drawingml/2006/table">
            <a:tbl>
              <a:tblPr>
                <a:tableStyleId>{793D81CF-94F2-401A-BA57-92F5A7B2D0C5}</a:tableStyleId>
              </a:tblPr>
              <a:tblGrid>
                <a:gridCol w="990600">
                  <a:extLst>
                    <a:ext uri="{9D8B030D-6E8A-4147-A177-3AD203B41FA5}">
                      <a16:colId xmlns:a16="http://schemas.microsoft.com/office/drawing/2014/main" val="1367225058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val="907598192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val="1717868622"/>
                    </a:ext>
                  </a:extLst>
                </a:gridCol>
              </a:tblGrid>
              <a:tr h="1600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Metabolites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 dirty="0" err="1">
                          <a:effectLst/>
                        </a:rPr>
                        <a:t>p.</a:t>
                      </a:r>
                      <a:r>
                        <a:rPr lang="pt-BR" sz="1000" u="none" strike="noStrike" dirty="0" err="1">
                          <a:effectLst/>
                        </a:rPr>
                        <a:t>value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FDR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331623684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C162-OH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65E-4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5,62E-3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362948933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C12-DC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42E-2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00E-2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1651894665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lysoPC a C18: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16E-2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67E-2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4105555667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lysoPC a C16: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8,75E-2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97E-2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4005288487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38: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9,79E-2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97E-2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1586049054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44: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54E-2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08E-19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2713811415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Trp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63E-2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5,59E-19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2797791326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38: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8,64E-2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67E-1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3480108259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44: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27E-1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92E-1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2148291522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lysoPC a C20: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54E-1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18E-1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1993373695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42: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45E-1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25E-1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1217266127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lysoPC a C18: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98E-1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72E-1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2587255268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38: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57E-1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20E-1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1336721924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42: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5,46E-1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6,09E-1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3792835911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42: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09E-1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15E-1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2873001484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SM (OH) C24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21E-1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23E-1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197131525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42: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57E-1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24E-1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2446404521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36: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5,34E-1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71E-1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3142927690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lysoPC a C20: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7,98E-1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6,76E-1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1202515213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38: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23E-1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01E-1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2119171661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C3-OH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19E-1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72E-1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2195695295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42: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13E-1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37E-1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2086572030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40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57E-1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61E-1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625383788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28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82E-1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70E-1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1456480615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42: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7,71E-1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5,27E-1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547818805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42: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31E-1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8,69E-1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2004157291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34: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71E-1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10E-1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2740521155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Lysine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95E-1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79E-1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2210144463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44: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7,00E-1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12E-1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2034028411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40: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8,61E-1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93E-1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4232000307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lysoPC a C18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16E-1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6,46E-1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2039871049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42: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47E-1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7,78E-1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1249268939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42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91E-1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9,85E-1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1662115233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40: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84E-1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40E-1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1713758210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38: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93E-1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41E-1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2055356346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38: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6,25E-1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74E-1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3237493388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40: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6,33E-1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74E-1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3588691302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Glucose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6,52E-1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76E-1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1652008580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SM C24: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02E-1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25E-1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2306888929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42: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53E-1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44E-1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2674423336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36: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38E-1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75E-1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3701181602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Total DMA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77E-1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87E-1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1815637381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40: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8,90E-1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43E-1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4103352675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SM (OH) C22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20E-1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52E-1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2161493763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40: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24E-1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63E-1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523775446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40: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36E-1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95E-1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1359290685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34: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40E-1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5,05E-1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377075930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36: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70E-1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6,00E-1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2517520444"/>
                  </a:ext>
                </a:extLst>
              </a:tr>
              <a:tr h="12883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36: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 dirty="0">
                          <a:effectLst/>
                        </a:rPr>
                        <a:t>2,40E-12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 dirty="0">
                          <a:effectLst/>
                        </a:rPr>
                        <a:t>8,36E-12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85" marR="3685" marT="3685" marB="0" anchor="b"/>
                </a:tc>
                <a:extLst>
                  <a:ext uri="{0D108BD9-81ED-4DB2-BD59-A6C34878D82A}">
                    <a16:rowId xmlns:a16="http://schemas.microsoft.com/office/drawing/2014/main" val="650781378"/>
                  </a:ext>
                </a:extLst>
              </a:tr>
            </a:tbl>
          </a:graphicData>
        </a:graphic>
      </p:graphicFrame>
      <p:graphicFrame>
        <p:nvGraphicFramePr>
          <p:cNvPr id="14" name="Tabela 13">
            <a:extLst>
              <a:ext uri="{FF2B5EF4-FFF2-40B4-BE49-F238E27FC236}">
                <a16:creationId xmlns:a16="http://schemas.microsoft.com/office/drawing/2014/main" id="{0F17CE7B-CB7E-43BC-8AFC-BF049F25FE97}"/>
              </a:ext>
            </a:extLst>
          </p:cNvPr>
          <p:cNvGraphicFramePr>
            <a:graphicFrameLocks noGrp="1"/>
          </p:cNvGraphicFramePr>
          <p:nvPr/>
        </p:nvGraphicFramePr>
        <p:xfrm>
          <a:off x="5702300" y="292100"/>
          <a:ext cx="2781303" cy="6475650"/>
        </p:xfrm>
        <a:graphic>
          <a:graphicData uri="http://schemas.openxmlformats.org/drawingml/2006/table">
            <a:tbl>
              <a:tblPr>
                <a:tableStyleId>{793D81CF-94F2-401A-BA57-92F5A7B2D0C5}</a:tableStyleId>
              </a:tblPr>
              <a:tblGrid>
                <a:gridCol w="927101">
                  <a:extLst>
                    <a:ext uri="{9D8B030D-6E8A-4147-A177-3AD203B41FA5}">
                      <a16:colId xmlns:a16="http://schemas.microsoft.com/office/drawing/2014/main" val="3803491101"/>
                    </a:ext>
                  </a:extLst>
                </a:gridCol>
                <a:gridCol w="927101">
                  <a:extLst>
                    <a:ext uri="{9D8B030D-6E8A-4147-A177-3AD203B41FA5}">
                      <a16:colId xmlns:a16="http://schemas.microsoft.com/office/drawing/2014/main" val="2925951384"/>
                    </a:ext>
                  </a:extLst>
                </a:gridCol>
                <a:gridCol w="927101">
                  <a:extLst>
                    <a:ext uri="{9D8B030D-6E8A-4147-A177-3AD203B41FA5}">
                      <a16:colId xmlns:a16="http://schemas.microsoft.com/office/drawing/2014/main" val="838585021"/>
                    </a:ext>
                  </a:extLst>
                </a:gridCol>
              </a:tblGrid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C4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80E-1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9,57E-1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2374056443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36: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7,47E-1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52E-1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3129776410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38: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9,37E-1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10E-1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4280185431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SDMA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63E-1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5,24E-1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1484047130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lysoPC a C17: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39E-1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39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4043848800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38: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6,79E-1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12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1992549177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38: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9,36E-1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88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4131052436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Citrulline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27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79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2620570627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36: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32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88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1105357005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42: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37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94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3302180369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lysoPC a C26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38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94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2055383521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Thr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45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06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2330738691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Val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46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06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732288459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38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96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5,32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1805933990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40: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30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6,16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745511967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SM (OH) C22: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25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8,61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3875826272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36: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46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9,04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1750959195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C5:1-DC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59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9,29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3612817645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40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6,50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66E-09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4083529245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leucine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7,38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86E-09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2961145911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C5-DC 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7,81E-1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95E-09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3539973750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C10: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33E-09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28E-09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1801368942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Histidine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79E-09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22E-09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352784320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38: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80E-09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22E-09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2714529998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32: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81E-09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22E-09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2382455510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C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03E-09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67E-09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1509863317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30: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32E-09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7,49E-09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2728757074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lysoPC a C16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97E-09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8,68E-09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2970758201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C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28E-09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9,26E-09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534700506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32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08E-0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26E-0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245917012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36: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14E-0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36E-0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766946514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40: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71E-0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52E-0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1051617596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34: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07E-0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22E-0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1422853559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40: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70E-0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5,41E-0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2739790082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34: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80E-0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5,54E-0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902784972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36: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08E-0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6,05E-0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1516871538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36: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37E-0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8,43E-0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3234195766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C5-M-DC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6,70E-08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28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3511631547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36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06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99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2433597255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38: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17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18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817882198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C7-DC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38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55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1597897699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34: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44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62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2603013870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32: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50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72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1977916447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40: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65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97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3795107557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ADMA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10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75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1106539315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36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26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99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1283971216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44: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67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68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3030157752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26: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81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89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1743571944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34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5,23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9,01E-07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4022069001"/>
                  </a:ext>
                </a:extLst>
              </a:tr>
              <a:tr h="129513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SM C16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24E-0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 dirty="0">
                          <a:effectLst/>
                        </a:rPr>
                        <a:t>2,10E-06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51" marR="4351" marT="4351" marB="0" anchor="b"/>
                </a:tc>
                <a:extLst>
                  <a:ext uri="{0D108BD9-81ED-4DB2-BD59-A6C34878D82A}">
                    <a16:rowId xmlns:a16="http://schemas.microsoft.com/office/drawing/2014/main" val="1842112822"/>
                  </a:ext>
                </a:extLst>
              </a:tr>
            </a:tbl>
          </a:graphicData>
        </a:graphic>
      </p:graphicFrame>
      <p:graphicFrame>
        <p:nvGraphicFramePr>
          <p:cNvPr id="15" name="Tabela 14">
            <a:extLst>
              <a:ext uri="{FF2B5EF4-FFF2-40B4-BE49-F238E27FC236}">
                <a16:creationId xmlns:a16="http://schemas.microsoft.com/office/drawing/2014/main" id="{19DD83F2-AD13-480C-836C-F0DC111B46EA}"/>
              </a:ext>
            </a:extLst>
          </p:cNvPr>
          <p:cNvGraphicFramePr>
            <a:graphicFrameLocks noGrp="1"/>
          </p:cNvGraphicFramePr>
          <p:nvPr/>
        </p:nvGraphicFramePr>
        <p:xfrm>
          <a:off x="8839200" y="292100"/>
          <a:ext cx="2679708" cy="5244363"/>
        </p:xfrm>
        <a:graphic>
          <a:graphicData uri="http://schemas.openxmlformats.org/drawingml/2006/table">
            <a:tbl>
              <a:tblPr>
                <a:tableStyleId>{793D81CF-94F2-401A-BA57-92F5A7B2D0C5}</a:tableStyleId>
              </a:tblPr>
              <a:tblGrid>
                <a:gridCol w="1020896">
                  <a:extLst>
                    <a:ext uri="{9D8B030D-6E8A-4147-A177-3AD203B41FA5}">
                      <a16:colId xmlns:a16="http://schemas.microsoft.com/office/drawing/2014/main" val="2941416777"/>
                    </a:ext>
                  </a:extLst>
                </a:gridCol>
                <a:gridCol w="765576">
                  <a:extLst>
                    <a:ext uri="{9D8B030D-6E8A-4147-A177-3AD203B41FA5}">
                      <a16:colId xmlns:a16="http://schemas.microsoft.com/office/drawing/2014/main" val="3894301951"/>
                    </a:ext>
                  </a:extLst>
                </a:gridCol>
                <a:gridCol w="893236">
                  <a:extLst>
                    <a:ext uri="{9D8B030D-6E8A-4147-A177-3AD203B41FA5}">
                      <a16:colId xmlns:a16="http://schemas.microsoft.com/office/drawing/2014/main" val="1635131427"/>
                    </a:ext>
                  </a:extLst>
                </a:gridCol>
              </a:tblGrid>
              <a:tr h="126541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Methionine-Sulfoxyde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36E-0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29E-0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3118149634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lysoPC a C26: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 dirty="0">
                          <a:effectLst/>
                        </a:rPr>
                        <a:t>1,81E-06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99E-0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816928857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SM C16: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04E-0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95E-0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4066441461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C142-OH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47E-0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5,62E-0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284802678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SM (OH) C14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6,67E-0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07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1237189765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Creatinine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7,60E-0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21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3507507356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32: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9,11E-06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44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2293458033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C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38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16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3559112566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SM C24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46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28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3826464815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Ala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54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38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2486139224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32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84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81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2479812363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24: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84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81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1079299486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C18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67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05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2858745930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SM C26: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70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06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1457948223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42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84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21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2735730208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C14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90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27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1407401393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32: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65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5,34E-05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1707867086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34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03E-0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49E-0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537144047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SM C26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40E-0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02E-0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1341442547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Methionine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04E-0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91E-0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3122050163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Serotonin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15E-0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45E-0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2521564400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Glutamine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64E-0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5,12E-0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2157998974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C9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5,39E-0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7,52E-0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1127364268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34: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5,67E-0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7,85E-0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575885848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Asp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8,10E-0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11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651985801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30: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8,81E-0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21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1545962347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C14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15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56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3438120833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Arg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45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96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3561988915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Glycine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58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12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272862506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C5-OH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70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27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2426053283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Taurine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10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77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4168763962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30: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59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39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596714374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SM (OH) C16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2,82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67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3793707400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a C38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02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91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2528573606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PC ae C36: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16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06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31370855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Isoleucine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42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37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3795688099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lysoPC a C28: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3,92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4,97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3240882514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lysoPC a C24: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6,10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7,66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1700536332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C12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7,55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9,41E-03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3196767594"/>
                  </a:ext>
                </a:extLst>
              </a:tr>
              <a:tr h="131208"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lysoPC a C28:1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>
                          <a:effectLst/>
                        </a:rPr>
                        <a:t>1,02E-02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 dirty="0">
                          <a:effectLst/>
                        </a:rPr>
                        <a:t>1,26E-02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31" marR="5331" marT="5331" marB="0" anchor="b"/>
                </a:tc>
                <a:extLst>
                  <a:ext uri="{0D108BD9-81ED-4DB2-BD59-A6C34878D82A}">
                    <a16:rowId xmlns:a16="http://schemas.microsoft.com/office/drawing/2014/main" val="11034416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086270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a 1"/>
          <p:cNvGraphicFramePr>
            <a:graphicFrameLocks noGrp="1"/>
          </p:cNvGraphicFramePr>
          <p:nvPr/>
        </p:nvGraphicFramePr>
        <p:xfrm>
          <a:off x="1696598" y="1432390"/>
          <a:ext cx="8498518" cy="2539365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512006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2615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2615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2615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b="1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etabolite</a:t>
                      </a:r>
                      <a:r>
                        <a:rPr lang="pt-BR" sz="1400" b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Set</a:t>
                      </a:r>
                    </a:p>
                  </a:txBody>
                  <a:tcPr marL="9525" marR="9525" marT="9525" marB="0" anchor="b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b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 </a:t>
                      </a:r>
                      <a:r>
                        <a:rPr lang="pt-BR" sz="1400" b="1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Value</a:t>
                      </a:r>
                      <a:endParaRPr lang="pt-BR" sz="1400" b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b="1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olm</a:t>
                      </a:r>
                      <a:r>
                        <a:rPr lang="pt-BR" sz="1400" b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P</a:t>
                      </a:r>
                    </a:p>
                  </a:txBody>
                  <a:tcPr marL="9525" marR="9525" marT="9525" marB="0" anchor="b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b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DR</a:t>
                      </a:r>
                    </a:p>
                  </a:txBody>
                  <a:tcPr marL="9525" marR="9525" marT="9525" marB="0" anchor="b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b="1" i="1" u="none" strike="noStrike" kern="1200" dirty="0" err="1">
                          <a:effectLst/>
                        </a:rPr>
                        <a:t>Tryptophan</a:t>
                      </a:r>
                      <a:r>
                        <a:rPr lang="pt-BR" sz="1400" b="1" i="1" u="none" strike="noStrike" kern="1200" dirty="0">
                          <a:effectLst/>
                        </a:rPr>
                        <a:t> </a:t>
                      </a:r>
                      <a:r>
                        <a:rPr lang="pt-BR" sz="1400" b="1" i="1" u="none" strike="noStrike" kern="1200" dirty="0" err="1">
                          <a:effectLst/>
                        </a:rPr>
                        <a:t>metabolism</a:t>
                      </a:r>
                      <a:endParaRPr lang="pt-BR" sz="1400" b="1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2.89e-85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8.39e-84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8.39e-84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i="1" u="none" strike="noStrike" kern="1200" dirty="0" err="1">
                          <a:effectLst/>
                        </a:rPr>
                        <a:t>Aminoacyl-tRNA</a:t>
                      </a:r>
                      <a:r>
                        <a:rPr lang="pt-BR" sz="1400" i="1" u="none" strike="noStrike" kern="1200" dirty="0">
                          <a:effectLst/>
                        </a:rPr>
                        <a:t> </a:t>
                      </a:r>
                      <a:r>
                        <a:rPr lang="pt-BR" sz="1400" i="1" u="none" strike="noStrike" kern="1200" dirty="0" err="1">
                          <a:effectLst/>
                        </a:rPr>
                        <a:t>biosynthesis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8.58e-40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2.40e-38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1.24e-38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i="1" u="none" strike="noStrike" kern="1200" dirty="0" err="1">
                          <a:effectLst/>
                        </a:rPr>
                        <a:t>Lysine</a:t>
                      </a:r>
                      <a:r>
                        <a:rPr lang="pt-BR" sz="1400" i="1" u="none" strike="noStrike" kern="1200" dirty="0">
                          <a:effectLst/>
                        </a:rPr>
                        <a:t> </a:t>
                      </a:r>
                      <a:r>
                        <a:rPr lang="pt-BR" sz="1400" i="1" u="none" strike="noStrike" kern="1200" dirty="0" err="1">
                          <a:effectLst/>
                        </a:rPr>
                        <a:t>degradation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1.20e-25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3.23e-24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8.67e-25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i="1" u="none" strike="noStrike" kern="1200" dirty="0" err="1">
                          <a:effectLst/>
                        </a:rPr>
                        <a:t>Biotin</a:t>
                      </a:r>
                      <a:r>
                        <a:rPr lang="pt-BR" sz="1400" i="1" u="none" strike="noStrike" kern="1200" dirty="0">
                          <a:effectLst/>
                        </a:rPr>
                        <a:t> </a:t>
                      </a:r>
                      <a:r>
                        <a:rPr lang="pt-BR" sz="1400" i="1" u="none" strike="noStrike" kern="1200" dirty="0" err="1">
                          <a:effectLst/>
                        </a:rPr>
                        <a:t>metabolism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1.20e-25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3.23e-24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8.67e-25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i="1" u="none" strike="noStrike" kern="1200" dirty="0" err="1">
                          <a:effectLst/>
                        </a:rPr>
                        <a:t>Valine</a:t>
                      </a:r>
                      <a:r>
                        <a:rPr lang="en-US" sz="1400" i="1" u="none" strike="noStrike" kern="1200" dirty="0">
                          <a:effectLst/>
                        </a:rPr>
                        <a:t>, </a:t>
                      </a:r>
                      <a:r>
                        <a:rPr lang="en-US" sz="1400" i="1" u="none" strike="noStrike" kern="1200" dirty="0" err="1">
                          <a:effectLst/>
                        </a:rPr>
                        <a:t>leucine</a:t>
                      </a:r>
                      <a:r>
                        <a:rPr lang="en-US" sz="1400" i="1" u="none" strike="noStrike" kern="1200" dirty="0">
                          <a:effectLst/>
                        </a:rPr>
                        <a:t> and isoleucine biosynthesis</a:t>
                      </a:r>
                      <a:endParaRPr lang="en-US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4.64e-23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1.16e-21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2.69e-22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i="1" u="none" strike="noStrike" kern="1200" dirty="0">
                          <a:effectLst/>
                        </a:rPr>
                        <a:t>Glycine, serine and threonine metabolism</a:t>
                      </a:r>
                      <a:endParaRPr lang="en-US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2.25e-17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5.40e-16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1.09e-16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i="1" u="none" strike="noStrike" kern="1200" dirty="0" err="1">
                          <a:effectLst/>
                        </a:rPr>
                        <a:t>Pantothenate</a:t>
                      </a:r>
                      <a:r>
                        <a:rPr lang="pt-BR" sz="1400" i="1" u="none" strike="noStrike" kern="1200" dirty="0">
                          <a:effectLst/>
                        </a:rPr>
                        <a:t> </a:t>
                      </a:r>
                      <a:r>
                        <a:rPr lang="pt-BR" sz="1400" i="1" u="none" strike="noStrike" kern="1200" dirty="0" err="1">
                          <a:effectLst/>
                        </a:rPr>
                        <a:t>and</a:t>
                      </a:r>
                      <a:r>
                        <a:rPr lang="pt-BR" sz="1400" i="1" u="none" strike="noStrike" kern="1200" dirty="0">
                          <a:effectLst/>
                        </a:rPr>
                        <a:t> </a:t>
                      </a:r>
                      <a:r>
                        <a:rPr lang="pt-BR" sz="1400" i="1" u="none" strike="noStrike" kern="1200" dirty="0" err="1">
                          <a:effectLst/>
                        </a:rPr>
                        <a:t>CoA</a:t>
                      </a:r>
                      <a:r>
                        <a:rPr lang="pt-BR" sz="1400" i="1" u="none" strike="noStrike" kern="1200" dirty="0">
                          <a:effectLst/>
                        </a:rPr>
                        <a:t> </a:t>
                      </a:r>
                      <a:r>
                        <a:rPr lang="pt-BR" sz="1400" i="1" u="none" strike="noStrike" kern="1200" dirty="0" err="1">
                          <a:effectLst/>
                        </a:rPr>
                        <a:t>biosynthesis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7.85e-16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1.81e-14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3.25e-15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fr-FR" sz="1400" i="1" u="none" strike="noStrike" kern="1200" dirty="0">
                          <a:effectLst/>
                        </a:rPr>
                        <a:t>Valine, leucine and isoleucine degradation</a:t>
                      </a:r>
                      <a:endParaRPr lang="fr-F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4.25e-14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9.35e-13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u="none" strike="noStrike" kern="1200" dirty="0">
                          <a:effectLst/>
                        </a:rPr>
                        <a:t>1.54e-13</a:t>
                      </a:r>
                      <a:endParaRPr lang="pt-BR" sz="1400" i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38100" marB="3810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graphicFrame>
        <p:nvGraphicFramePr>
          <p:cNvPr id="4" name="Tabela 3"/>
          <p:cNvGraphicFramePr>
            <a:graphicFrameLocks noGrp="1"/>
          </p:cNvGraphicFramePr>
          <p:nvPr/>
        </p:nvGraphicFramePr>
        <p:xfrm>
          <a:off x="2740292" y="4666646"/>
          <a:ext cx="6273800" cy="1670685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368254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7033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9542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b="1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etabolite</a:t>
                      </a:r>
                      <a:r>
                        <a:rPr lang="pt-BR" sz="1400" b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Set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b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pt-BR" sz="1400" b="1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Value</a:t>
                      </a:r>
                      <a:endParaRPr lang="pt-BR" sz="1400" b="1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b="1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olm</a:t>
                      </a:r>
                      <a:r>
                        <a:rPr lang="pt-BR" sz="1400" b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P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pt-BR" sz="1400" b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DR</a:t>
                      </a: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pt-BR" sz="1400" b="1" i="1" u="none" strike="noStrike" dirty="0" err="1">
                          <a:effectLst/>
                        </a:rPr>
                        <a:t>Hartnup</a:t>
                      </a:r>
                      <a:r>
                        <a:rPr lang="pt-BR" sz="1400" b="1" i="1" u="none" strike="noStrike" dirty="0">
                          <a:effectLst/>
                        </a:rPr>
                        <a:t> </a:t>
                      </a:r>
                      <a:r>
                        <a:rPr lang="pt-BR" sz="1400" b="1" i="1" u="none" strike="noStrike" dirty="0" err="1">
                          <a:effectLst/>
                        </a:rPr>
                        <a:t>Disease</a:t>
                      </a:r>
                      <a:endParaRPr lang="pt-BR" sz="14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400" u="none" strike="noStrike" dirty="0">
                          <a:effectLst/>
                        </a:rPr>
                        <a:t>2.06e-34</a:t>
                      </a:r>
                      <a:endParaRPr lang="pt-B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400" u="none" strike="noStrike" dirty="0">
                          <a:effectLst/>
                        </a:rPr>
                        <a:t>1.87e-32</a:t>
                      </a:r>
                      <a:endParaRPr lang="pt-B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400" u="none" strike="noStrike" dirty="0">
                          <a:effectLst/>
                        </a:rPr>
                        <a:t>1.85e-33</a:t>
                      </a:r>
                    </a:p>
                  </a:txBody>
                  <a:tcPr marL="9525" marR="9525" marT="38100" marB="3810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pt-BR" sz="1400" i="1" u="none" strike="noStrike" dirty="0" err="1">
                          <a:effectLst/>
                        </a:rPr>
                        <a:t>Carnitine</a:t>
                      </a:r>
                      <a:r>
                        <a:rPr lang="pt-BR" sz="1400" i="1" u="none" strike="noStrike" dirty="0">
                          <a:effectLst/>
                        </a:rPr>
                        <a:t> </a:t>
                      </a:r>
                      <a:r>
                        <a:rPr lang="pt-BR" sz="1400" i="1" u="none" strike="noStrike" dirty="0" err="1">
                          <a:effectLst/>
                        </a:rPr>
                        <a:t>Palmitoyl</a:t>
                      </a:r>
                      <a:r>
                        <a:rPr lang="pt-BR" sz="1400" i="1" u="none" strike="noStrike" dirty="0">
                          <a:effectLst/>
                        </a:rPr>
                        <a:t> </a:t>
                      </a:r>
                      <a:r>
                        <a:rPr lang="pt-BR" sz="1400" i="1" u="none" strike="noStrike" dirty="0" err="1">
                          <a:effectLst/>
                        </a:rPr>
                        <a:t>Transferase</a:t>
                      </a:r>
                      <a:r>
                        <a:rPr lang="pt-BR" sz="1400" i="1" u="none" strike="noStrike" dirty="0">
                          <a:effectLst/>
                        </a:rPr>
                        <a:t> </a:t>
                      </a:r>
                      <a:r>
                        <a:rPr lang="pt-BR" sz="1400" i="1" u="none" strike="noStrike" dirty="0" err="1">
                          <a:effectLst/>
                        </a:rPr>
                        <a:t>Deficiency</a:t>
                      </a:r>
                      <a:r>
                        <a:rPr lang="pt-BR" sz="1400" i="1" u="none" strike="noStrike" dirty="0">
                          <a:effectLst/>
                        </a:rPr>
                        <a:t> (II)</a:t>
                      </a:r>
                      <a:endParaRPr lang="pt-BR" sz="14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400" u="none" strike="noStrike" dirty="0">
                          <a:effectLst/>
                        </a:rPr>
                        <a:t>2.78e-21</a:t>
                      </a:r>
                      <a:endParaRPr lang="pt-B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400" u="none" strike="noStrike" dirty="0">
                          <a:effectLst/>
                        </a:rPr>
                        <a:t>2.58e-19</a:t>
                      </a:r>
                      <a:endParaRPr lang="pt-B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400" u="none" strike="noStrike" dirty="0">
                          <a:effectLst/>
                        </a:rPr>
                        <a:t>3.93e-20</a:t>
                      </a:r>
                      <a:endParaRPr lang="pt-B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38100" marB="3810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pt-BR" sz="1400" i="1" u="none" strike="noStrike" dirty="0" err="1">
                          <a:effectLst/>
                        </a:rPr>
                        <a:t>Isobutyryl-CoA</a:t>
                      </a:r>
                      <a:r>
                        <a:rPr lang="pt-BR" sz="1400" i="1" u="none" strike="noStrike" dirty="0">
                          <a:effectLst/>
                        </a:rPr>
                        <a:t> </a:t>
                      </a:r>
                      <a:r>
                        <a:rPr lang="pt-BR" sz="1400" i="1" u="none" strike="noStrike" dirty="0" err="1">
                          <a:effectLst/>
                        </a:rPr>
                        <a:t>Dehydrogenase</a:t>
                      </a:r>
                      <a:r>
                        <a:rPr lang="pt-BR" sz="1400" i="1" u="none" strike="noStrike" dirty="0">
                          <a:effectLst/>
                        </a:rPr>
                        <a:t> </a:t>
                      </a:r>
                      <a:r>
                        <a:rPr lang="pt-BR" sz="1400" i="1" u="none" strike="noStrike" dirty="0" err="1">
                          <a:effectLst/>
                        </a:rPr>
                        <a:t>Deficiency</a:t>
                      </a:r>
                      <a:endParaRPr lang="pt-BR" sz="14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400" u="none" strike="noStrike" dirty="0">
                          <a:effectLst/>
                        </a:rPr>
                        <a:t>9.42e-19</a:t>
                      </a:r>
                      <a:endParaRPr lang="pt-B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400" u="none" strike="noStrike" dirty="0">
                          <a:effectLst/>
                        </a:rPr>
                        <a:t>8.57e-17</a:t>
                      </a:r>
                      <a:endParaRPr lang="pt-B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400" u="none" strike="noStrike" dirty="0">
                          <a:effectLst/>
                        </a:rPr>
                        <a:t>8.54e-18</a:t>
                      </a:r>
                      <a:endParaRPr lang="pt-B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38100" marB="3810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i="1" u="none" strike="noStrike" dirty="0">
                          <a:effectLst/>
                        </a:rPr>
                        <a:t>Short Chain Acyl-CoA Dehydrogenase Deficiency 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400" u="none" strike="noStrike" dirty="0">
                          <a:effectLst/>
                        </a:rPr>
                        <a:t>9.42e-19</a:t>
                      </a:r>
                      <a:endParaRPr lang="pt-B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400" u="none" strike="noStrike" dirty="0">
                          <a:effectLst/>
                        </a:rPr>
                        <a:t>8.57e-17</a:t>
                      </a:r>
                      <a:endParaRPr lang="pt-B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400" u="none" strike="noStrike" dirty="0">
                          <a:effectLst/>
                        </a:rPr>
                        <a:t>8.54e-18</a:t>
                      </a:r>
                      <a:endParaRPr lang="pt-B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38100" marB="3810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pt-BR" sz="1400" i="1" u="none" strike="noStrike" dirty="0" err="1">
                          <a:effectLst/>
                        </a:rPr>
                        <a:t>Glutaric</a:t>
                      </a:r>
                      <a:r>
                        <a:rPr lang="pt-BR" sz="1400" i="1" u="none" strike="noStrike" dirty="0">
                          <a:effectLst/>
                        </a:rPr>
                        <a:t> </a:t>
                      </a:r>
                      <a:r>
                        <a:rPr lang="pt-BR" sz="1400" i="1" u="none" strike="noStrike" dirty="0" err="1">
                          <a:effectLst/>
                        </a:rPr>
                        <a:t>Aciduria</a:t>
                      </a:r>
                      <a:r>
                        <a:rPr lang="pt-BR" sz="1400" i="1" u="none" strike="noStrike" dirty="0">
                          <a:effectLst/>
                        </a:rPr>
                        <a:t> II</a:t>
                      </a:r>
                      <a:endParaRPr lang="pt-BR" sz="14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400" u="none" strike="noStrike" dirty="0">
                          <a:effectLst/>
                        </a:rPr>
                        <a:t>7.87e-22</a:t>
                      </a:r>
                      <a:endParaRPr lang="pt-B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400" u="none" strike="noStrike" dirty="0">
                          <a:effectLst/>
                        </a:rPr>
                        <a:t>5.59e-20</a:t>
                      </a:r>
                      <a:endParaRPr lang="pt-B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38100" marB="3810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400" u="none" strike="noStrike" dirty="0">
                          <a:effectLst/>
                        </a:rPr>
                        <a:t>2.69e-21</a:t>
                      </a:r>
                    </a:p>
                  </a:txBody>
                  <a:tcPr marL="9525" marR="9525" marT="38100" marB="3810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5" name="CaixaDeTexto 4"/>
          <p:cNvSpPr txBox="1"/>
          <p:nvPr/>
        </p:nvSpPr>
        <p:spPr>
          <a:xfrm>
            <a:off x="1674564" y="627961"/>
            <a:ext cx="8527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b="1" dirty="0" err="1"/>
              <a:t>Unsupervised</a:t>
            </a:r>
            <a:r>
              <a:rPr lang="pt-BR" b="1" dirty="0"/>
              <a:t> </a:t>
            </a:r>
            <a:r>
              <a:rPr lang="pt-BR" b="1" dirty="0" err="1"/>
              <a:t>Targeted</a:t>
            </a:r>
            <a:r>
              <a:rPr lang="pt-BR" b="1" dirty="0"/>
              <a:t> </a:t>
            </a:r>
            <a:r>
              <a:rPr lang="pt-BR" b="1" dirty="0" err="1"/>
              <a:t>Quantitative</a:t>
            </a:r>
            <a:r>
              <a:rPr lang="pt-BR" b="1" dirty="0"/>
              <a:t> </a:t>
            </a:r>
            <a:r>
              <a:rPr lang="pt-BR" b="1" dirty="0" err="1"/>
              <a:t>Enrichment</a:t>
            </a:r>
            <a:r>
              <a:rPr lang="pt-BR" b="1" dirty="0"/>
              <a:t> </a:t>
            </a:r>
            <a:r>
              <a:rPr lang="pt-BR" b="1" dirty="0" err="1"/>
              <a:t>Analysis</a:t>
            </a:r>
            <a:r>
              <a:rPr lang="pt-BR" b="1" dirty="0"/>
              <a:t> </a:t>
            </a:r>
          </a:p>
        </p:txBody>
      </p:sp>
      <p:sp>
        <p:nvSpPr>
          <p:cNvPr id="3" name="CaixaDeTexto 2">
            <a:extLst>
              <a:ext uri="{FF2B5EF4-FFF2-40B4-BE49-F238E27FC236}">
                <a16:creationId xmlns:a16="http://schemas.microsoft.com/office/drawing/2014/main" id="{2B775332-8E49-4649-B50F-BC0D341B011A}"/>
              </a:ext>
            </a:extLst>
          </p:cNvPr>
          <p:cNvSpPr txBox="1"/>
          <p:nvPr/>
        </p:nvSpPr>
        <p:spPr>
          <a:xfrm>
            <a:off x="135467" y="228158"/>
            <a:ext cx="27262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600" b="1" dirty="0" err="1"/>
              <a:t>Supplemental</a:t>
            </a:r>
            <a:r>
              <a:rPr lang="pt-BR" sz="1600" b="1" dirty="0"/>
              <a:t> material 2</a:t>
            </a:r>
          </a:p>
        </p:txBody>
      </p:sp>
    </p:spTree>
    <p:extLst>
      <p:ext uri="{BB962C8B-B14F-4D97-AF65-F5344CB8AC3E}">
        <p14:creationId xmlns:p14="http://schemas.microsoft.com/office/powerpoint/2010/main" val="40888640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a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54279561"/>
              </p:ext>
            </p:extLst>
          </p:nvPr>
        </p:nvGraphicFramePr>
        <p:xfrm>
          <a:off x="1014471" y="668506"/>
          <a:ext cx="10515598" cy="1916240"/>
        </p:xfrm>
        <a:graphic>
          <a:graphicData uri="http://schemas.openxmlformats.org/drawingml/2006/table">
            <a:tbl>
              <a:tblPr/>
              <a:tblGrid>
                <a:gridCol w="149308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9308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9308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9308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9308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05019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8312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kern="1200" dirty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Amino acids</a:t>
                      </a:r>
                      <a:endParaRPr lang="pt-BR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.value</a:t>
                      </a:r>
                      <a:endParaRPr lang="pt-BR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.value</a:t>
                      </a:r>
                      <a:endParaRPr lang="pt-BR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log10(p)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DR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sher's</a:t>
                      </a:r>
                      <a:r>
                        <a:rPr lang="pt-B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LSD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p</a:t>
                      </a:r>
                      <a:endParaRPr lang="pt-B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.822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71e-21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327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73e-20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&gt; (ISS1+2)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&gt; ISS3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; b-(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SS1+2) &gt; ISS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ys</a:t>
                      </a:r>
                      <a:endParaRPr lang="pt-B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.375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25e-15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034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63e-14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&gt; (ISS1+2)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&gt; ISS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r</a:t>
                      </a:r>
                      <a:endParaRPr lang="pt-B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906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2e-10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466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08e-10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&gt; (ISS1+2)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&gt; ISS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t</a:t>
                      </a:r>
                      <a:endParaRPr lang="pt-B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038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11e-10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2138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6e-09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&gt; (ISS1+2)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&gt; ISS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l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.715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99e-09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525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04e-09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&gt; (ISS1+2)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&gt; ISS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u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69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3e-08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5975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60e-08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&gt; (ISS1+2)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&gt; ISS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56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75e-08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2401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96e-08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&gt; (ISS1+2)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&gt; ISS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a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525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93e-05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53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18e-05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&gt; (ISS1+2)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&gt; ISS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</a:t>
                      </a:r>
                      <a:endParaRPr lang="pt-B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1111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1e-04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6539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02e-04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SS3 &gt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; ISS3  &gt; (ISS1+2)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graphicFrame>
        <p:nvGraphicFramePr>
          <p:cNvPr id="3" name="Tabela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2853365"/>
              </p:ext>
            </p:extLst>
          </p:nvPr>
        </p:nvGraphicFramePr>
        <p:xfrm>
          <a:off x="970403" y="2740649"/>
          <a:ext cx="10515598" cy="1724616"/>
        </p:xfrm>
        <a:graphic>
          <a:graphicData uri="http://schemas.openxmlformats.org/drawingml/2006/table">
            <a:tbl>
              <a:tblPr/>
              <a:tblGrid>
                <a:gridCol w="149308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9308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9308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9308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9308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05019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kern="1200" dirty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Acyl carnitines</a:t>
                      </a:r>
                      <a:endParaRPr lang="pt-BR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.value</a:t>
                      </a:r>
                      <a:endParaRPr lang="pt-BR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.value</a:t>
                      </a:r>
                      <a:endParaRPr lang="pt-BR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log10(p)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DR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sher's</a:t>
                      </a:r>
                      <a:r>
                        <a:rPr lang="pt-B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LSD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3-OH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.316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0e-15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722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21e-15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-(ISS1+2) &gt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; ISS3 &gt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41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85e-1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545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29e-1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ISS1+2) &gt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; ISS3 &gt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; ISS3  &gt; (ISS1+2)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5-DC 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.827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76e-1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425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9e-12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ISS1+2) &gt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; ISS3 &gt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; ISS3  &gt; (ISS1+2)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102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624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05e-11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516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05e-11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ISS1+2) &gt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; ISS3 &gt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; ISS3  &gt; (ISS1+2)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4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117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80e-10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2367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1e-09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ISS1+2) &gt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; ISS3 &gt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; ISS3  &gt; (ISS1+2)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5-M-DC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.917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0e-09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5859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30e-09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ISS1+2) &gt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; ISS3 &gt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; ISS3  &gt; (ISS1+2)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2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.189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30e-09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3664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57e-09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ISS1+2) &gt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; ISS3 </a:t>
                      </a:r>
                      <a:r>
                        <a:rPr lang="en-US" sz="12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&gt;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5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248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2e-07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8191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8e-07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SS3 &gt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; ISS3  &gt; (ISS1+2)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graphicFrame>
        <p:nvGraphicFramePr>
          <p:cNvPr id="4" name="Tabe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41526417"/>
              </p:ext>
            </p:extLst>
          </p:nvPr>
        </p:nvGraphicFramePr>
        <p:xfrm>
          <a:off x="970402" y="4811121"/>
          <a:ext cx="10515598" cy="1532992"/>
        </p:xfrm>
        <a:graphic>
          <a:graphicData uri="http://schemas.openxmlformats.org/drawingml/2006/table">
            <a:tbl>
              <a:tblPr/>
              <a:tblGrid>
                <a:gridCol w="149308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9308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9308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9308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9308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05019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pids</a:t>
                      </a:r>
                      <a:endParaRPr lang="pt-BR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.value</a:t>
                      </a:r>
                      <a:endParaRPr lang="pt-BR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.value</a:t>
                      </a:r>
                      <a:endParaRPr lang="pt-BR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log10(p)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DR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sher's</a:t>
                      </a:r>
                      <a:r>
                        <a:rPr lang="pt-B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LSD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</a:t>
                      </a:r>
                      <a:r>
                        <a:rPr lang="pt-B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Ms</a:t>
                      </a:r>
                      <a:endParaRPr lang="pt-B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.299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04e-09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095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6e-08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&gt; (ISS1+2)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&gt; ISS3; (ISS1+2) &gt; ISS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PC </a:t>
                      </a:r>
                      <a:r>
                        <a:rPr lang="pt-B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e</a:t>
                      </a:r>
                      <a:endParaRPr lang="pt-B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.65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38e-16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028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20e-15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&gt; (ISS1+2)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&gt; ISS3; (ISS1+2) &gt; ISS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PC aa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.131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2e-17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88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69e-17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&gt; (ISS1+2)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&gt; ISS3; (ISS1+2) &gt; ISS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LPC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4.07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4e-22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944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3e-21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&gt; (ISS1+2)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&gt; ISS3; (ISS1+2) &gt; ISS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ruct</a:t>
                      </a:r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 </a:t>
                      </a:r>
                      <a:r>
                        <a:rPr lang="pt-B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pids</a:t>
                      </a:r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Glucose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7.42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3e-27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988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5e-26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&gt; (ISS1+2)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&gt; ISS3; (ISS1+2) &gt; ISS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ruct</a:t>
                      </a:r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 </a:t>
                      </a:r>
                      <a:r>
                        <a:rPr lang="pt-B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pids</a:t>
                      </a:r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pt-B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n</a:t>
                      </a:r>
                      <a:endParaRPr lang="pt-B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.94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11e-09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2918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1e-08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&gt; (ISS1+2)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&gt; ISS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74871"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ruct</a:t>
                      </a:r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 </a:t>
                      </a:r>
                      <a:r>
                        <a:rPr lang="pt-B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pids</a:t>
                      </a:r>
                      <a:endParaRPr lang="pt-B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.217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6e-20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665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1e-19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&gt; (ISS1+2);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&gt; ISS3; (ISS1+2) &gt;</a:t>
                      </a:r>
                      <a:r>
                        <a:rPr lang="en-US" sz="12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SS3</a:t>
                      </a:r>
                    </a:p>
                  </a:txBody>
                  <a:tcPr marL="8744" marR="8744" marT="87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5" name="CaixaDeTexto 4">
            <a:extLst>
              <a:ext uri="{FF2B5EF4-FFF2-40B4-BE49-F238E27FC236}">
                <a16:creationId xmlns:a16="http://schemas.microsoft.com/office/drawing/2014/main" id="{411947B1-53E1-4498-8630-F690FB28897D}"/>
              </a:ext>
            </a:extLst>
          </p:cNvPr>
          <p:cNvSpPr txBox="1"/>
          <p:nvPr/>
        </p:nvSpPr>
        <p:spPr>
          <a:xfrm>
            <a:off x="135467" y="228158"/>
            <a:ext cx="27262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400" b="1" dirty="0" err="1"/>
              <a:t>Supplemental</a:t>
            </a:r>
            <a:r>
              <a:rPr lang="pt-BR" sz="1400" b="1" dirty="0"/>
              <a:t> material 3</a:t>
            </a:r>
          </a:p>
        </p:txBody>
      </p:sp>
    </p:spTree>
    <p:extLst>
      <p:ext uri="{BB962C8B-B14F-4D97-AF65-F5344CB8AC3E}">
        <p14:creationId xmlns:p14="http://schemas.microsoft.com/office/powerpoint/2010/main" val="185591941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9</TotalTime>
  <Words>1383</Words>
  <Application>Microsoft Office PowerPoint</Application>
  <PresentationFormat>Widescreen</PresentationFormat>
  <Paragraphs>662</Paragraphs>
  <Slides>4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o Office</vt:lpstr>
      <vt:lpstr>Biochemical Phenotyping of Multiple Myeloma Patients at Diagnosis Reveals a Disorder of Mitochondrial Complexes I and II and a Hartnup-Like Disturbance as Underlying Conditions, also Influencing Different Stages of the Disease  </vt:lpstr>
      <vt:lpstr>Supplemental material 1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iochemical Phenotyping of Multiple Myeloma Patients at Diagnosis Reveals a Disorder of Mitochondrial Complexes I and II and a Hartnup-Like Disturbance as Underlying Conditions, also Influencing Different Stages of the Disease</dc:title>
  <dc:creator>Windows 8.1</dc:creator>
  <cp:lastModifiedBy>Windows 8.1</cp:lastModifiedBy>
  <cp:revision>3</cp:revision>
  <dcterms:created xsi:type="dcterms:W3CDTF">2020-06-16T18:34:46Z</dcterms:created>
  <dcterms:modified xsi:type="dcterms:W3CDTF">2020-10-14T14:09:09Z</dcterms:modified>
</cp:coreProperties>
</file>